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9" r:id="rId3"/>
    <p:sldId id="265" r:id="rId4"/>
    <p:sldId id="266" r:id="rId5"/>
    <p:sldId id="268" r:id="rId6"/>
    <p:sldId id="264" r:id="rId7"/>
    <p:sldId id="267" r:id="rId8"/>
  </p:sldIdLst>
  <p:sldSz cx="6119813" cy="75596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928" autoAdjust="0"/>
    <p:restoredTop sz="94660"/>
  </p:normalViewPr>
  <p:slideViewPr>
    <p:cSldViewPr snapToGrid="0">
      <p:cViewPr>
        <p:scale>
          <a:sx n="100" d="100"/>
          <a:sy n="100" d="100"/>
        </p:scale>
        <p:origin x="4506" y="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F8E6B0-4FB7-431F-967A-935046A18B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64977" y="1237197"/>
            <a:ext cx="4589860" cy="2631887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744A909-1339-4219-8786-F2D464B9E9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64977" y="3970580"/>
            <a:ext cx="4589860" cy="1825171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E4294B-7E1B-4156-8CF4-A5FFAFEE4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D827D9-C0F4-43D2-A3E7-98EB8DF83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AD6573-3A58-4A9B-A1FC-0AB599ACB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2227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51176C-A6C2-4C4D-87A6-A698CB06B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95DD9E7-94E3-4D57-8EC8-83D8518DEF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2683EA-E27C-4C9B-B62C-10A0EFF10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224ECE-732B-44FD-BC8C-DB06581F0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E7422D-BD22-4D17-8EAA-688459865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1915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E19B64A-16BF-4BC8-B407-69AB1CA64E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379491" y="402483"/>
            <a:ext cx="1319585" cy="64064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366BF1-86C0-49F4-89A6-5F2FBE600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20737" y="402483"/>
            <a:ext cx="3882256" cy="64064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2E9158-E307-4FBA-B0E9-45043B677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32CDC6-8454-46CE-BD57-DFF245AD3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6E99EF-FB74-468F-8776-F85C49C1A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901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2E3397-FAD6-4687-8A02-5A84C31D6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DAE97B-1170-4BF6-829D-086E9CF7F8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B94E62-F801-4D4A-AE9D-648FDC5E0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67E12A-A879-49C9-8C1F-E60E67392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3B10CF-68DF-42C2-A71A-501D7A785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7585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82C630-F192-4095-83C2-A68BEE1BBE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7550" y="1884670"/>
            <a:ext cx="5278339" cy="3144614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BE95A6-1847-4BDA-A2FF-2C80DE892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17550" y="5059034"/>
            <a:ext cx="5278339" cy="165367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3FDC67-25ED-40EA-975F-70A9D07BF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8FC705-6C98-4A67-87BD-E181F292B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FD1155-4938-4D1C-A642-21A58C90D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945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3112D7-A02F-4111-A4E8-1D9FD1738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8779E6-41D5-4C4E-AA78-1825339747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20737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E088A7-C1F9-4433-B4CA-6388188E0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098155" y="2012414"/>
            <a:ext cx="2600921" cy="479654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784B8A-49C4-4AD0-B778-999DB46E8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0AF43B-EAB6-4EC0-A63D-95FE37C4C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5EB91E9-28EC-4491-B784-BDC5FCE7C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5186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A1C149-264E-4687-9A0F-2E6C0E690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402483"/>
            <a:ext cx="5278339" cy="1461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33F7D2-CEE4-4674-8BB5-26AB9F174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1534" y="1853171"/>
            <a:ext cx="2588968" cy="908210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074AF2-7544-4024-8E05-52F695B325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21534" y="2761381"/>
            <a:ext cx="2588968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839E13A-E2BE-4414-923D-2CEBE1306A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098155" y="1853171"/>
            <a:ext cx="2601718" cy="908210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9C40EEF-F43F-4627-83B3-C93C24BA28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098155" y="2761381"/>
            <a:ext cx="2601718" cy="40615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94BDAFB-5FF1-403A-AD6D-00A6591D4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7883C85-2795-4DDB-961D-313CE2C66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FCA1F1B-2559-4EAE-AF87-F81562F31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046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D5CF40-C47D-48D7-916E-B8A24731D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9FCF2A9-F6B2-4938-8620-854D4AFF26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86A336-5F7E-4009-9F00-6834D2C21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15D7AD5-6752-41AF-978A-E9EB21AC1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448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829F5F6-7EB2-4EDA-B75F-1976D2EBE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DE780B3-F1D8-4AC4-B255-A1B605E65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EB9D2CE-91C0-47C1-85FF-9E83D56CA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941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0B960E-7B93-4FD1-8D18-BF0E2CA331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99C364-E90F-4724-818B-0C9AFAB588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01718" y="1088454"/>
            <a:ext cx="3098155" cy="5372269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7BF18D-F5E5-48ED-BB2E-A9A44A5C75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CFCDAD0-CC2D-4E81-8D22-A1C06107E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7651DD-E3FC-4E61-B448-AD30B8913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7C6D8C-D8AA-49A3-9C7A-14B0AB488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93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232B9B-4F6A-468D-A762-3386D177B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534" y="503978"/>
            <a:ext cx="1973799" cy="1763924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20FC9A5-4C03-4EC1-905D-4A4D828F6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601718" y="1088454"/>
            <a:ext cx="3098155" cy="5372269"/>
          </a:xfrm>
        </p:spPr>
        <p:txBody>
          <a:bodyPr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EA0F77-D4B7-4BC5-93F2-CF08C285B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21534" y="2267902"/>
            <a:ext cx="1973799" cy="4201570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43546E-68EE-4277-8557-E48E6416F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E544AA-E31A-4BDF-8288-40975548D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A8A484-A2D2-4A63-84B7-496C51F65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611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904C208-6889-4CF5-981E-1451463DE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737" y="402483"/>
            <a:ext cx="527833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99C786-4E9F-446A-99A2-36156E969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20737" y="2012414"/>
            <a:ext cx="527833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E25615-EFD5-4B3B-A464-8E9756F23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20737" y="7006699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D01C9-9DB5-4F94-A4D9-FF6D522116B2}" type="datetimeFigureOut">
              <a:rPr lang="zh-CN" altLang="en-US" smtClean="0"/>
              <a:t>2021/11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2411AD-4D64-4C3C-B572-C02CA55F16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027188" y="7006699"/>
            <a:ext cx="206543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4773A1-DB40-4960-8656-069B49D0C5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322118" y="7006699"/>
            <a:ext cx="13769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2BEF0F-1445-4A98-B080-CC63813EF3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5025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59029" rtl="0" eaLnBrk="1" latinLnBrk="0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0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707E6ABF-84F8-4F58-987C-4C59989761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802" y="728340"/>
            <a:ext cx="3701675" cy="125423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18A0E8A-7F18-429E-9E24-CD3A0743BDB9}"/>
              </a:ext>
            </a:extLst>
          </p:cNvPr>
          <p:cNvSpPr txBox="1"/>
          <p:nvPr/>
        </p:nvSpPr>
        <p:spPr>
          <a:xfrm>
            <a:off x="678947" y="1982578"/>
            <a:ext cx="476191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1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elected ion monitoring (SIM)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romatograms of the 17β-estradiol (E2) standard. E2 was dissolved in methanol. The monitored ion in the mass spectrum had a mass/charge ratio of 506 m/z and a retention time of 6.0 min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 descr="图表, 箱线图&#10;&#10;描述已自动生成">
            <a:extLst>
              <a:ext uri="{FF2B5EF4-FFF2-40B4-BE49-F238E27FC236}">
                <a16:creationId xmlns:a16="http://schemas.microsoft.com/office/drawing/2014/main" id="{E430B4E3-D7B0-4291-9EA8-38B44CA483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3858" y="3923490"/>
            <a:ext cx="3229213" cy="119634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6895633-F790-452C-BB9C-F24FC44EA544}"/>
              </a:ext>
            </a:extLst>
          </p:cNvPr>
          <p:cNvSpPr txBox="1"/>
          <p:nvPr/>
        </p:nvSpPr>
        <p:spPr>
          <a:xfrm>
            <a:off x="678947" y="5326625"/>
            <a:ext cx="47619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等线" panose="02010600030101010101" pitchFamily="2" charset="-122"/>
              </a:rPr>
              <a:t>Fig. S2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Box plots present the mRNA expression levels of</a:t>
            </a:r>
            <a:r>
              <a:rPr lang="en-US" altLang="zh-CN" sz="1200" i="1" dirty="0">
                <a:latin typeface="Times New Roman" panose="02020603050405020304" pitchFamily="18" charset="0"/>
                <a:ea typeface="等线" panose="02010600030101010101" pitchFamily="2" charset="-122"/>
              </a:rPr>
              <a:t> Hes1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等线" panose="02010600030101010101" pitchFamily="2" charset="-122"/>
              </a:rPr>
              <a:t>Hes2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等线" panose="02010600030101010101" pitchFamily="2" charset="-122"/>
              </a:rPr>
              <a:t>Hey1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等线" panose="02010600030101010101" pitchFamily="2" charset="-122"/>
              </a:rPr>
              <a:t>Hey2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and </a:t>
            </a:r>
            <a:r>
              <a:rPr lang="en-US" altLang="zh-CN" sz="1200" i="1" dirty="0" err="1">
                <a:latin typeface="Times New Roman" panose="02020603050405020304" pitchFamily="18" charset="0"/>
                <a:ea typeface="等线" panose="02010600030101010101" pitchFamily="2" charset="-122"/>
              </a:rPr>
              <a:t>HeyL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in normal prostate and prostate cancer tissues based on TCGA data.</a:t>
            </a:r>
            <a:endParaRPr lang="zh-CN" altLang="en-US" sz="12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D93EB58-6F9D-4209-B24B-AF0F0F61A5D1}"/>
              </a:ext>
            </a:extLst>
          </p:cNvPr>
          <p:cNvSpPr txBox="1"/>
          <p:nvPr/>
        </p:nvSpPr>
        <p:spPr>
          <a:xfrm>
            <a:off x="856176" y="236940"/>
            <a:ext cx="20328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s </a:t>
            </a:r>
            <a:endParaRPr lang="zh-CN" altLang="zh-CN" sz="14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889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, 散点图&#10;&#10;描述已自动生成">
            <a:extLst>
              <a:ext uri="{FF2B5EF4-FFF2-40B4-BE49-F238E27FC236}">
                <a16:creationId xmlns:a16="http://schemas.microsoft.com/office/drawing/2014/main" id="{714C68E5-6924-49AC-9EC3-91DD3615CE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846" y="3267817"/>
            <a:ext cx="2022717" cy="222274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D0CC242-E46A-462F-B439-66D2FD66D210}"/>
              </a:ext>
            </a:extLst>
          </p:cNvPr>
          <p:cNvSpPr txBox="1"/>
          <p:nvPr/>
        </p:nvSpPr>
        <p:spPr>
          <a:xfrm>
            <a:off x="654331" y="5559614"/>
            <a:ext cx="48252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4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rrelation analysis betwee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the estrogen response gene set in normal prostate and PRAD tissues from TCGA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0" name="图片 9" descr="图表&#10;&#10;描述已自动生成">
            <a:extLst>
              <a:ext uri="{FF2B5EF4-FFF2-40B4-BE49-F238E27FC236}">
                <a16:creationId xmlns:a16="http://schemas.microsoft.com/office/drawing/2014/main" id="{DDE05DE3-101F-4FAF-8C37-791F4E3159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9469" y="734751"/>
            <a:ext cx="1724142" cy="1560596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7538C82-34AD-4F88-9EDC-5CDB59B5F5A2}"/>
              </a:ext>
            </a:extLst>
          </p:cNvPr>
          <p:cNvSpPr txBox="1"/>
          <p:nvPr/>
        </p:nvSpPr>
        <p:spPr>
          <a:xfrm>
            <a:off x="654331" y="2213944"/>
            <a:ext cx="49973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3</a:t>
            </a:r>
            <a:endParaRPr lang="en-US" altLang="zh-CN" sz="12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aplan–Meier survival curves showing disease-free survival differences between PRAD patients in the Hey2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gh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Hey2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ow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bgroups from TCGA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4372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电脑萤幕画面&#10;&#10;中度可信度描述已自动生成">
            <a:extLst>
              <a:ext uri="{FF2B5EF4-FFF2-40B4-BE49-F238E27FC236}">
                <a16:creationId xmlns:a16="http://schemas.microsoft.com/office/drawing/2014/main" id="{81823EB8-4DC1-4CFA-AA9B-ABAB2EA87A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887" y="5097113"/>
            <a:ext cx="3022038" cy="88219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3281C1F-B63F-4C80-9154-606BCD53EBBC}"/>
              </a:ext>
            </a:extLst>
          </p:cNvPr>
          <p:cNvSpPr txBox="1"/>
          <p:nvPr/>
        </p:nvSpPr>
        <p:spPr>
          <a:xfrm>
            <a:off x="647298" y="6042306"/>
            <a:ext cx="48252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6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graphs of IF data for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aromatase i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a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issues, scale bar: 50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97D2791-12F1-4EEC-AB81-22DB00ED647B}"/>
              </a:ext>
            </a:extLst>
          </p:cNvPr>
          <p:cNvSpPr txBox="1"/>
          <p:nvPr/>
        </p:nvSpPr>
        <p:spPr>
          <a:xfrm>
            <a:off x="647298" y="2571750"/>
            <a:ext cx="4825218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5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silencing efficiency in PC3,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22RV1 cells was verified by western blot analysis. To establish stable cell lines, PC3 and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 were transduced with control (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SPRi_lacZ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or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knockdown (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SPRi_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lentiviral particles for 72 h and selected with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lasticidin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22RV1 cells were transfected with the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SPRko_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lasmids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 descr="图表, 条形图&#10;&#10;描述已自动生成">
            <a:extLst>
              <a:ext uri="{FF2B5EF4-FFF2-40B4-BE49-F238E27FC236}">
                <a16:creationId xmlns:a16="http://schemas.microsoft.com/office/drawing/2014/main" id="{59A20134-22CB-473E-8A2A-598461F468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0181" y="648462"/>
            <a:ext cx="3060192" cy="1923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1346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02D22D8-2B1B-45D6-A334-49D98D49377C}"/>
              </a:ext>
            </a:extLst>
          </p:cNvPr>
          <p:cNvSpPr txBox="1"/>
          <p:nvPr/>
        </p:nvSpPr>
        <p:spPr>
          <a:xfrm>
            <a:off x="425731" y="4908184"/>
            <a:ext cx="5085470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7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romatase functions to maintain the characteristics of PCSCs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aromatase silencing efficiency in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PC3 cells was confirmed by using western blot analysis. The protein levels of aromatase in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PC3 cells transfected with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Ctr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siCYP19A1 are shown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-C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morsphere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forming ability of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 transfected with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Ctr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siCYP19A1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micrographs (scale bar: 100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Quantitative results (t-test)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low cytometry analysis of the CD4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/CD2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−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ubpopulation among PC3 cells transfected with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Ctr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siCYP19A1. </a:t>
            </a:r>
            <a:r>
              <a:rPr lang="zh-CN" altLang="en-US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-F</a:t>
            </a:r>
            <a:r>
              <a:rPr lang="zh-CN" altLang="en-US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）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mRNA levels of stemness-associated genes were analyzed after knockdown of CYP19A1 in PC3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and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ells (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‐test). The data are presented as the mean ± SD values (n=3). *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5 vs. ctrl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 descr="图示&#10;&#10;描述已自动生成">
            <a:extLst>
              <a:ext uri="{FF2B5EF4-FFF2-40B4-BE49-F238E27FC236}">
                <a16:creationId xmlns:a16="http://schemas.microsoft.com/office/drawing/2014/main" id="{FA53E26E-F7FB-433C-8174-2ECD86D9CC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249" y="264232"/>
            <a:ext cx="4051313" cy="4549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81141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DDDD7BB-F24B-408C-8FD2-628CB4684D3F}"/>
              </a:ext>
            </a:extLst>
          </p:cNvPr>
          <p:cNvSpPr txBox="1"/>
          <p:nvPr/>
        </p:nvSpPr>
        <p:spPr>
          <a:xfrm>
            <a:off x="484346" y="2995007"/>
            <a:ext cx="515112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8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ffect of endogenous estrogen on the expression of BCL2,</a:t>
            </a:r>
            <a:r>
              <a:rPr lang="zh-CN" altLang="en-US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X</a:t>
            </a:r>
            <a:r>
              <a:rPr lang="zh-CN" altLang="en-US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zh-CN" altLang="en-US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D44.</a:t>
            </a:r>
          </a:p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BAX/BCL2 ratio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)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CD44 expression levels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in LNCaP cells after the indicated treatments (one-way ANOVA).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BAX/BCL2 ratio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and CD44 expression levels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in PC3 cells after the indicated treatments (one-way ANOVA)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BAX/BCL2 ratio in PC3 cells treated with ICI182780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or transfected with siESR1</a:t>
            </a:r>
            <a:r>
              <a:rPr lang="el-GR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(t-test). Bic, bicalutamide. The data are presented as the mean ± SD values (n=3). *p&lt;0.05 vs. ctrl. #p&lt;0.05 vs.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_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图片 4" descr="图表, 条形图&#10;&#10;描述已自动生成">
            <a:extLst>
              <a:ext uri="{FF2B5EF4-FFF2-40B4-BE49-F238E27FC236}">
                <a16:creationId xmlns:a16="http://schemas.microsoft.com/office/drawing/2014/main" id="{8948625A-A4A0-4040-9AFA-4B0471FDFC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0358" y="335889"/>
            <a:ext cx="3060192" cy="2563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3664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0DF0A8F-C38F-4D21-9390-CA91243C7636}"/>
              </a:ext>
            </a:extLst>
          </p:cNvPr>
          <p:cNvSpPr txBox="1"/>
          <p:nvPr/>
        </p:nvSpPr>
        <p:spPr>
          <a:xfrm>
            <a:off x="383234" y="2579508"/>
            <a:ext cx="507063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9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ffect of ER signaling o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induced phenotype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morsphere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forming ability of LNCaP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b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 treated as indicated. The protein levels of ERα, representative micrographs are shown in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and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respectively. Scale bar: 100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The data are presented as the mean ± SD values (n=3). *p&lt;0.05 vs. ctrl. #p&lt;0.05 vs. OE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 descr="散点图&#10;&#10;描述已自动生成">
            <a:extLst>
              <a:ext uri="{FF2B5EF4-FFF2-40B4-BE49-F238E27FC236}">
                <a16:creationId xmlns:a16="http://schemas.microsoft.com/office/drawing/2014/main" id="{4883B03E-AC9A-42FA-96DD-E67A75E886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46" y="781426"/>
            <a:ext cx="4868411" cy="1407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67397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图表, 条形图&#10;&#10;描述已自动生成">
            <a:extLst>
              <a:ext uri="{FF2B5EF4-FFF2-40B4-BE49-F238E27FC236}">
                <a16:creationId xmlns:a16="http://schemas.microsoft.com/office/drawing/2014/main" id="{E4BCADBF-8C47-4DFB-81FB-9207B48068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2209" y="4871973"/>
            <a:ext cx="1325873" cy="138526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537B9D5-43EA-4DAA-A985-AC4F5E72C3AE}"/>
              </a:ext>
            </a:extLst>
          </p:cNvPr>
          <p:cNvSpPr txBox="1"/>
          <p:nvPr/>
        </p:nvSpPr>
        <p:spPr>
          <a:xfrm>
            <a:off x="571500" y="6257241"/>
            <a:ext cx="500634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11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RNA levels of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R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SA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ctrl or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overexpressing LNCaP cells were analyzed (t-test). The data are presented as the mean ± SD values (n=3). *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5 vs. ctrl.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5779F3B-E270-425D-B679-B84A75D7A05A}"/>
              </a:ext>
            </a:extLst>
          </p:cNvPr>
          <p:cNvSpPr txBox="1"/>
          <p:nvPr/>
        </p:nvSpPr>
        <p:spPr>
          <a:xfrm>
            <a:off x="571500" y="3213726"/>
            <a:ext cx="515112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10</a:t>
            </a:r>
          </a:p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ffect of ER signaling on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induced genes expression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)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Rα expression levels was confirmed by using western blot analysis. The protein levels of ERα in PC3 cells after the indicated treatments are shown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xpression levels of the stemness- and autophagy- associated genes in PC3 cells treated as indicated (one-way ANOVA). (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BAX/BCL2 ratio in PC3 cells after the indicated treatments (one-way ANOVA). The data are presented as the mean ± SD values (n=3). *p&lt;0.05 vs. ctrl. #p&lt;0.05 vs. OE-</a:t>
            </a:r>
            <a:r>
              <a:rPr lang="en-US" altLang="zh-CN" sz="12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yL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 descr="图表, 条形图&#10;&#10;描述已自动生成">
            <a:extLst>
              <a:ext uri="{FF2B5EF4-FFF2-40B4-BE49-F238E27FC236}">
                <a16:creationId xmlns:a16="http://schemas.microsoft.com/office/drawing/2014/main" id="{3C3B4332-A18D-4827-957E-A59D9B6C90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500" y="1587033"/>
            <a:ext cx="5253588" cy="1410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990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8</TotalTime>
  <Words>758</Words>
  <Application>Microsoft Office PowerPoint</Application>
  <PresentationFormat>自定义</PresentationFormat>
  <Paragraphs>24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启妹</dc:creator>
  <cp:lastModifiedBy>林 启妹</cp:lastModifiedBy>
  <cp:revision>16</cp:revision>
  <dcterms:created xsi:type="dcterms:W3CDTF">2021-09-30T14:19:19Z</dcterms:created>
  <dcterms:modified xsi:type="dcterms:W3CDTF">2021-11-10T15:50:47Z</dcterms:modified>
</cp:coreProperties>
</file>